
<file path=[Content_Types].xml><?xml version="1.0" encoding="utf-8"?>
<Types xmlns="http://schemas.openxmlformats.org/package/2006/content-types">
  <Default Extension="jpeg" ContentType="image/jpeg"/>
  <Default Extension="mov" ContentType="video/quicktime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1"/>
    <p:restoredTop sz="94673"/>
  </p:normalViewPr>
  <p:slideViewPr>
    <p:cSldViewPr snapToGrid="0">
      <p:cViewPr varScale="1">
        <p:scale>
          <a:sx n="115" d="100"/>
          <a:sy n="115" d="100"/>
        </p:scale>
        <p:origin x="1016" y="2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2EC17AA-4506-7BE9-1A39-4B3FCF863BE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C80B018-D380-8E9D-86F6-27109F01735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D2FC343-B435-C65C-9ACC-22D91025EE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612FA7-971E-8346-A55E-2DBFAEF3A553}" type="datetimeFigureOut">
              <a:rPr lang="en-US" smtClean="0"/>
              <a:t>12/16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A428204-BC81-9D2E-AE3C-B7169F3405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F77AAD7-F4A8-72EA-BBB0-91CB74A72C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3890DE-625F-7F4F-88F0-C70D43BF11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32012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6C18FA9-F001-89A9-C69C-AB9F7E3F237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C7F3145-5802-922C-77A1-4D35C51E231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8A47068-0D62-78B5-07E5-745FB914DF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612FA7-971E-8346-A55E-2DBFAEF3A553}" type="datetimeFigureOut">
              <a:rPr lang="en-US" smtClean="0"/>
              <a:t>12/16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E32DE93-C2E0-1FB0-3803-BD8234350F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41DFF1C-0FAA-86A3-0291-72990ABCA5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3890DE-625F-7F4F-88F0-C70D43BF11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78745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4E738E4-CEA6-9FE4-9300-DB3FFF51C7A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9F3A249-F39F-AACC-57BB-8270A9E4F99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FE76E1B-BCEA-89C5-2CCC-8FD033E79F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612FA7-971E-8346-A55E-2DBFAEF3A553}" type="datetimeFigureOut">
              <a:rPr lang="en-US" smtClean="0"/>
              <a:t>12/16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B2F2E7A-BE29-1D4E-2AC5-6BE7300F7A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82A699F-F0F8-A90D-628C-9671646D49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3890DE-625F-7F4F-88F0-C70D43BF11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0918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B4C93E1-14CE-C505-75A8-A94970CD88C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7257D80-14FB-F369-9F6E-F134527BCBB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1A30706-1DAF-A8C2-565D-498844A57B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612FA7-971E-8346-A55E-2DBFAEF3A553}" type="datetimeFigureOut">
              <a:rPr lang="en-US" smtClean="0"/>
              <a:t>12/16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422F021-E4A5-D773-5B00-498DB959C1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A3FED3E-1A6F-D6C5-F0C4-F87B699AE4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3890DE-625F-7F4F-88F0-C70D43BF11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0022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7C0CC40-D2D7-B648-5DF3-EF8794FD17E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9D95989-04A6-11EB-E618-A01924F9555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360431C-53E7-B4F1-C443-95D9A2E126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612FA7-971E-8346-A55E-2DBFAEF3A553}" type="datetimeFigureOut">
              <a:rPr lang="en-US" smtClean="0"/>
              <a:t>12/16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3400EA3-6402-12FE-048C-0E6BFE120B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B7C907A-97CA-BBD4-581C-73FF38CE41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3890DE-625F-7F4F-88F0-C70D43BF11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77735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033181-F891-E100-D917-2008951CA8C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52584DD-D092-0140-3B2B-FA03FE83A1C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56557E7-F912-839D-09E6-7443DDAF02F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1607671-8DAD-6058-745F-831FD12C2A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612FA7-971E-8346-A55E-2DBFAEF3A553}" type="datetimeFigureOut">
              <a:rPr lang="en-US" smtClean="0"/>
              <a:t>12/16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7BA58C6-EE60-60C7-208E-2A41D40B94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CB2BCC3-A064-46D7-E5D9-37FB7A6AAD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3890DE-625F-7F4F-88F0-C70D43BF11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51103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60D3438-8F03-19F2-10D1-DE88F427AE9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E76BA77-841A-CEFC-09CB-EBEB06827E0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C8B8BCD-56F8-C0A1-6244-4666297DCF8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7044421-26B9-30E8-C5CA-97FDE019CAD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FDC50DB-E59B-39C1-A8A5-2C82FA88019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E502B12-9BE1-FBCF-33E9-E1386E5949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612FA7-971E-8346-A55E-2DBFAEF3A553}" type="datetimeFigureOut">
              <a:rPr lang="en-US" smtClean="0"/>
              <a:t>12/16/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81156F1-B816-D95D-504E-3AFF67C5BE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2BA33C5-6057-8C86-87B5-944C4214EE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3890DE-625F-7F4F-88F0-C70D43BF11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75065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92996D4-BF9B-84FB-94B5-A7C0502FFA6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FC34B30-6FAC-8FCE-4635-8B07F0032B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612FA7-971E-8346-A55E-2DBFAEF3A553}" type="datetimeFigureOut">
              <a:rPr lang="en-US" smtClean="0"/>
              <a:t>12/16/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EDC9CF7-2AD5-9321-88F5-F9C31EFF21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8186AFA-0892-6B0B-D171-06CEC6DE59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3890DE-625F-7F4F-88F0-C70D43BF11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32422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8ADA56C-2226-49E2-C5DA-35245EF107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612FA7-971E-8346-A55E-2DBFAEF3A553}" type="datetimeFigureOut">
              <a:rPr lang="en-US" smtClean="0"/>
              <a:t>12/16/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A369DFA-8F80-A8C4-1929-45E3D00E69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33CCA82-04F4-85B7-CFB6-DA6D0A5E13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3890DE-625F-7F4F-88F0-C70D43BF11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52225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BCAC696-1CE4-ECF7-7662-AD2F4B19CE8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9B9AD4C-E4A4-1BC8-7E23-238432E61E2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1B48F4B-64FB-5F58-169E-48CF5FCF939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F87E2DE-2408-C67D-56E9-9A136DEFC8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612FA7-971E-8346-A55E-2DBFAEF3A553}" type="datetimeFigureOut">
              <a:rPr lang="en-US" smtClean="0"/>
              <a:t>12/16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78C8701-8381-5727-55BE-C4468DF0AA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803D17A-DDAF-7340-BC5D-25FA872E86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3890DE-625F-7F4F-88F0-C70D43BF11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22733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EA296CA-8F94-6929-A384-3CA39989AEB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8ACB2BB-A881-F627-AAA1-3A1225794D4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B17976E-4B3D-899D-D923-F3BFD163FDF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671AB66-C4F4-82A3-C887-1792206EBD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612FA7-971E-8346-A55E-2DBFAEF3A553}" type="datetimeFigureOut">
              <a:rPr lang="en-US" smtClean="0"/>
              <a:t>12/16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FA22C82-36B1-79DA-F129-B5BA531FBE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EB53BAA-CCAD-227A-BE04-713F5EAF20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3890DE-625F-7F4F-88F0-C70D43BF11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81951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04DF18D-6095-DB1A-43D6-6456EE6C12C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401355C-7570-5E06-3FB3-3E5886F676B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B3AF9F2-520A-6D31-7067-7C1769930F7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6612FA7-971E-8346-A55E-2DBFAEF3A553}" type="datetimeFigureOut">
              <a:rPr lang="en-US" smtClean="0"/>
              <a:t>12/16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6167B4B-BE97-A296-CF62-4AA0F51FC6A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E5F8683-9C8E-D15A-C104-97A0EB3FCDE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F3890DE-625F-7F4F-88F0-C70D43BF11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1319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video" Target="../media/media1.mov"/><Relationship Id="rId1" Type="http://schemas.microsoft.com/office/2007/relationships/media" Target="../media/media1.mov"/><Relationship Id="rId4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Supplementary Video 2.mov">
            <a:hlinkClick r:id="" action="ppaction://media"/>
            <a:extLst>
              <a:ext uri="{FF2B5EF4-FFF2-40B4-BE49-F238E27FC236}">
                <a16:creationId xmlns:a16="http://schemas.microsoft.com/office/drawing/2014/main" id="{7E2C3AA8-58B6-B9B1-AED2-B6F4003EAB18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1524000" y="0"/>
            <a:ext cx="9144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08618902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24000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5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5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5"/>
                  </p:tgtEl>
                </p:cond>
              </p:nextCondLst>
            </p:seq>
          </p:childTnLst>
        </p:cTn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70F68392-8B31-6A28-A4FD-0B21E1F697FE}"/>
              </a:ext>
            </a:extLst>
          </p:cNvPr>
          <p:cNvSpPr txBox="1"/>
          <p:nvPr/>
        </p:nvSpPr>
        <p:spPr>
          <a:xfrm>
            <a:off x="1441704" y="565645"/>
            <a:ext cx="9308592" cy="688643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200000"/>
              </a:lnSpc>
              <a:spcBef>
                <a:spcPts val="1200"/>
              </a:spcBef>
              <a:spcAft>
                <a:spcPts val="1200"/>
              </a:spcAft>
              <a:buNone/>
            </a:pPr>
            <a:r>
              <a:rPr lang="en-US" sz="18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SimSun" panose="02010600030101010101" pitchFamily="2" charset="-122"/>
              </a:rPr>
              <a:t>Supplementary Video 2</a:t>
            </a:r>
            <a:endParaRPr lang="en-US" sz="1800" dirty="0">
              <a:effectLst/>
              <a:latin typeface="Times New Roman" panose="02020603050405020304" pitchFamily="18" charset="0"/>
              <a:ea typeface="SimSun" panose="02010600030101010101" pitchFamily="2" charset="-122"/>
            </a:endParaRPr>
          </a:p>
          <a:p>
            <a:pPr marL="0" marR="0" algn="just">
              <a:lnSpc>
                <a:spcPct val="200000"/>
              </a:lnSpc>
              <a:buNone/>
            </a:pPr>
            <a:r>
              <a:rPr lang="en-US" sz="18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SimSun" panose="02010600030101010101" pitchFamily="2" charset="-122"/>
              </a:rPr>
              <a:t>3D reconstitution of the p53-PITP</a:t>
            </a:r>
            <a:r>
              <a:rPr lang="el-GR" sz="18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SimSun" panose="02010600030101010101" pitchFamily="2" charset="-122"/>
              </a:rPr>
              <a:t>β</a:t>
            </a:r>
            <a:r>
              <a:rPr lang="en-US" sz="18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SimSun" panose="02010600030101010101" pitchFamily="2" charset="-122"/>
              </a:rPr>
              <a:t> complex in the nucleoplasm of MDA-MB-231 cells under stress</a:t>
            </a:r>
            <a:endParaRPr lang="en-US" sz="1800" dirty="0">
              <a:effectLst/>
              <a:latin typeface="Times New Roman" panose="02020603050405020304" pitchFamily="18" charset="0"/>
              <a:ea typeface="SimSun" panose="02010600030101010101" pitchFamily="2" charset="-122"/>
            </a:endParaRPr>
          </a:p>
          <a:p>
            <a:pPr marL="0" marR="0" algn="just">
              <a:lnSpc>
                <a:spcPct val="200000"/>
              </a:lnSpc>
              <a:spcBef>
                <a:spcPts val="600"/>
              </a:spcBef>
              <a:spcAft>
                <a:spcPts val="600"/>
              </a:spcAft>
            </a:pPr>
            <a:r>
              <a:rPr lang="en-US" sz="1800" b="0" kern="14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MDA-MB-231 cells were treated with 30 µM cisplatin for 24 h before being processed for PLA between p53 and PITP</a:t>
            </a:r>
            <a:r>
              <a:rPr lang="el-GR" sz="1800" b="0" kern="14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β</a:t>
            </a:r>
            <a:r>
              <a:rPr lang="el-GR" sz="1800" b="0" kern="1400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</a:t>
            </a:r>
            <a:r>
              <a:rPr lang="en-US" sz="1800" b="0" kern="14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(Red). Lamin A/C stained the nuclear envelope (Green), and the nuclei were counter-stained with DAPI (Blue). The z-stack images were taken with a Leica SP8 confocal microscope with each frame over a 0.2 </a:t>
            </a:r>
            <a:r>
              <a:rPr lang="en-US" sz="1800" b="0" kern="14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  <a:sym typeface="Symbol" pitchFamily="2" charset="2"/>
              </a:rPr>
              <a:t></a:t>
            </a:r>
            <a:r>
              <a:rPr lang="en-US" sz="1800" b="0" kern="14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m thickness. The video of the 3D reconstitution of a representative cell from three independent experiments was generated by LASX.</a:t>
            </a:r>
            <a:endParaRPr lang="en-US" sz="2000" b="1" kern="14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4661833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103</Words>
  <Application>Microsoft Macintosh PowerPoint</Application>
  <PresentationFormat>Widescreen</PresentationFormat>
  <Paragraphs>3</Paragraphs>
  <Slides>2</Slides>
  <Notes>0</Notes>
  <HiddenSlides>0</HiddenSlides>
  <MMClips>1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ptos</vt:lpstr>
      <vt:lpstr>Aptos Display</vt:lpstr>
      <vt:lpstr>Arial</vt:lpstr>
      <vt:lpstr>Times New Roman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Noah Carrillo</dc:creator>
  <cp:lastModifiedBy>Noah Carrillo</cp:lastModifiedBy>
  <cp:revision>2</cp:revision>
  <dcterms:created xsi:type="dcterms:W3CDTF">2025-12-16T14:32:49Z</dcterms:created>
  <dcterms:modified xsi:type="dcterms:W3CDTF">2025-12-16T14:37:27Z</dcterms:modified>
</cp:coreProperties>
</file>